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6" r:id="rId2"/>
    <p:sldId id="354" r:id="rId3"/>
    <p:sldId id="360" r:id="rId4"/>
    <p:sldId id="359" r:id="rId5"/>
    <p:sldId id="260" r:id="rId6"/>
    <p:sldId id="3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85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A51349-2954-4919-86E4-A2014C96B346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E25942-3DFF-4630-A460-A27C0CABEF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8877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229EEB-037B-544C-8D9A-EDD29A4F24F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320093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FF8B0C-E807-4655-8B55-11F0C8ECB66D}" type="slidenum">
              <a:rPr lang="en-IN" smtClean="0"/>
              <a:t>5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920656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E25942-3DFF-4630-A460-A27C0CABEF91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67073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F9A4DB-5B49-14F0-8EA7-7B2D354B354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C43C0AB-ECB6-8514-B1C0-20E2DDCC98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196699-DD87-5114-8A99-76E37D6A32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38D99-B197-4ED3-94C3-45DCA0FFA6D2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A22B0B-C387-F452-A951-4A824995F4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566347-6735-BFC3-747A-F0D6AE5794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F7B98-137F-46A5-85C3-544A531C17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2885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857C63-9BA3-C990-D7C1-27E009F47C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9D5BC4-DE3D-D56A-BF07-19B9A3580F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241369-8FEA-998B-1283-0AE17E6339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38D99-B197-4ED3-94C3-45DCA0FFA6D2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BB129F-57DD-E5EF-B0FF-9CB1D38714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34EBAA-09B8-6D5B-CF98-51F37BAA2B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F7B98-137F-46A5-85C3-544A531C17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7974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654C870-CCF0-B7E7-42B8-E5CDD8D5BA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0AE6274-3A88-C89D-B537-2D880D8A99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FFF78D-6AD9-BC77-B8F8-625717CCDB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38D99-B197-4ED3-94C3-45DCA0FFA6D2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4B6108-2F5F-0091-9B10-B0E2BD231A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93C1B9-0C22-916E-D2B0-33B2190299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F7B98-137F-46A5-85C3-544A531C17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181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0857D4-1E44-1E19-54EA-BE14F437CD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071B91-F75B-1EF0-706F-8C0D7BF950B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67A35C-2A20-30F4-B985-3E42F549F7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38D99-B197-4ED3-94C3-45DCA0FFA6D2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B037EA-605F-DBE6-7282-B3BFE4482D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3B0080-4A62-FCF2-4EBE-B175F6DDE3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F7B98-137F-46A5-85C3-544A531C17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4276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56CF4B-8A66-C64A-D782-28E8CEC2EC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B47428-4E2A-D880-ABD0-C6943E8989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DCB5B3-E6EE-2C25-ABBD-36F00FBE50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38D99-B197-4ED3-94C3-45DCA0FFA6D2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E0C953-CBF8-84BE-6322-D136421BCA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2DCE4D-355E-8E99-330D-601AE371E5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F7B98-137F-46A5-85C3-544A531C17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01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E96606-9782-ED89-C97B-6D9D4ECFC8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156DA1-C604-810A-3F36-FEB19B4DD1B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8DE749-6BB6-DE0D-5FCF-400DCE8619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070EA0-CB3A-8A42-C57D-AF1043E373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38D99-B197-4ED3-94C3-45DCA0FFA6D2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6C844B-4BA6-92B6-9B9A-08EAEA131B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457507-1AE7-1CEB-1E04-3462A8601D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F7B98-137F-46A5-85C3-544A531C17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018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FEF1EF-0F46-BBAD-31F7-55083FA7D5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023B02-3B73-A018-0669-D3D4E9E14F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55E1C2-1358-D470-D197-2CBA01A1EE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3CB27FA-54C3-1082-1DF2-2F14EAE090E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748B36D-1E12-491F-BD8D-403D715161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74556DA-ED0A-13B7-50B4-9A98814F32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38D99-B197-4ED3-94C3-45DCA0FFA6D2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5BC7C33-38D1-CE1A-2C3B-3DF127DB9B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C84DABE-B25B-8630-7847-CF1CEF2353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F7B98-137F-46A5-85C3-544A531C17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7748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66FD28-E5F2-4DA8-E6C2-0EF93A1F16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1DC5F4-9733-F4B2-55B2-840F78E263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38D99-B197-4ED3-94C3-45DCA0FFA6D2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B4ABD55-E4FD-0A27-FE23-97479F9FD7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0C2FCDF-EAF6-5BC3-E10E-A40D535154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F7B98-137F-46A5-85C3-544A531C17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160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E697222-7AB1-3A2D-75E9-EB79D77F00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38D99-B197-4ED3-94C3-45DCA0FFA6D2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407DECB-358D-5B92-20BF-BEDB6F8DC7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0771699-21C6-6127-E34B-A216632BAB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F7B98-137F-46A5-85C3-544A531C17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72484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415F0-EA3B-4ECC-3436-D32D8B35B3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9EF9C1-61B3-DDDF-31A9-F816E350D9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1884C28-5288-E567-0CA1-62FF233D67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25DACE-1C3F-330F-F98E-D01FA88E8B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38D99-B197-4ED3-94C3-45DCA0FFA6D2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446345-AEE7-4581-9C31-BD1A3B814E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B2F8C8-E0B0-BE36-5C9F-2FE354A8E9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F7B98-137F-46A5-85C3-544A531C17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5953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AE982F-B063-8930-61CB-75406319A0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2BC4269-12A2-7A28-34E9-5038DDF8859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C0D9A7-E3F2-6DD7-AA96-F52FF5033E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19F88F-9675-268E-49E1-412772242C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38D99-B197-4ED3-94C3-45DCA0FFA6D2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409BB6-0197-79AB-CE59-6779D964D4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63EA77-9998-B94C-1BDE-DA9EFCF295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F7B98-137F-46A5-85C3-544A531C17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6687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4A8593B-99D6-61F4-CED0-EE3C20C2D2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08314C-1E51-65DB-BDE0-BCBE971333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B3BA1D-2688-AB35-AE3D-7F9B2ED4066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F538D99-B197-4ED3-94C3-45DCA0FFA6D2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B8CCC2-ECED-BE72-70BF-9DE9214DBC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2267ED-9FF1-A3B2-92C5-21FD9161349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5EF7B98-137F-46A5-85C3-544A531C17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2138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hyperlink" Target="https://ejnu-my.sharepoint.com/:v:/g/personal/habire04_jnu_ac_kr/EW5ZnNOTJv1HvYdWmcIWBPsBkQ8rJbLBAzBIO4Df0mW5tg?nav=eyJyZWZlcnJhbEluZm8iOnsicmVmZXJyYWxBcHAiOiJPbmVEcml2ZUZvckJ1c2luZXNzIiwicmVmZXJyYWxBcHBQbGF0Zm9ybSI6IldlYiIsInJlZmVycmFsTW9kZSI6InZpZXciLCJyZWZlcnJhbFZpZXciOiJNeUZpbGVzTGlua0NvcHkifX0&amp;e=1HqwrV" TargetMode="Externa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6" Type="http://schemas.openxmlformats.org/officeDocument/2006/relationships/hyperlink" Target="https://ejnu-my.sharepoint.com/:v:/g/personal/habire04_jnu_ac_kr/EazhIz85DbFJkaqAQiL9KbYBImd9tqJW_OuYSSZZozdjDQ?nav=eyJyZWZlcnJhbEluZm8iOnsicmVmZXJyYWxBcHAiOiJPbmVEcml2ZUZvckJ1c2luZXNzIiwicmVmZXJyYWxBcHBQbGF0Zm9ybSI6IldlYiIsInJlZmVycmFsTW9kZSI6InZpZXciLCJyZWZlcnJhbFZpZXciOiJNeUZpbGVzTGlua0NvcHkifX0&amp;e=uEXMGR" TargetMode="External"/><Relationship Id="rId5" Type="http://schemas.openxmlformats.org/officeDocument/2006/relationships/image" Target="../media/image5.png"/><Relationship Id="rId4" Type="http://schemas.openxmlformats.org/officeDocument/2006/relationships/notesSlide" Target="../notesSlides/notesSlide1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g"/><Relationship Id="rId3" Type="http://schemas.openxmlformats.org/officeDocument/2006/relationships/image" Target="../media/image6.jpg"/><Relationship Id="rId7" Type="http://schemas.openxmlformats.org/officeDocument/2006/relationships/image" Target="../media/image10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jpg"/><Relationship Id="rId5" Type="http://schemas.openxmlformats.org/officeDocument/2006/relationships/image" Target="../media/image8.png"/><Relationship Id="rId4" Type="http://schemas.openxmlformats.org/officeDocument/2006/relationships/image" Target="../media/image7.tif"/><Relationship Id="rId9" Type="http://schemas.openxmlformats.org/officeDocument/2006/relationships/image" Target="../media/image12.em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A26726-6B1B-1AA2-FB74-36F320681833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sz="2000" b="1" dirty="0">
                <a:latin typeface="Aptos" panose="020B0004020202020204" pitchFamily="34" charset="0"/>
              </a:rPr>
              <a:t>Pretreatment Mitigates Myocardial Ischemia-Reperfusion Injury through Preservation of Mitochondrial Respiration: A Combined Assessment of </a:t>
            </a:r>
            <a:br>
              <a:rPr lang="en-US" sz="2000" b="1" dirty="0">
                <a:latin typeface="Aptos" panose="020B0004020202020204" pitchFamily="34" charset="0"/>
              </a:rPr>
            </a:br>
            <a:r>
              <a:rPr lang="en-US" sz="2000" b="1" dirty="0">
                <a:latin typeface="Aptos" panose="020B0004020202020204" pitchFamily="34" charset="0"/>
              </a:rPr>
              <a:t>In vivo, Ex vivo, and In vitro Data</a:t>
            </a:r>
            <a:br>
              <a:rPr lang="en-US" sz="2000" b="1" dirty="0">
                <a:latin typeface="Aptos" panose="020B0004020202020204" pitchFamily="34" charset="0"/>
              </a:rPr>
            </a:br>
            <a:endParaRPr lang="en-US" sz="2000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9F49C16-3715-2E80-5AA1-5C4E80A7DC0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60206" y="3509963"/>
            <a:ext cx="9144000" cy="1655762"/>
          </a:xfrm>
        </p:spPr>
        <p:txBody>
          <a:bodyPr/>
          <a:lstStyle/>
          <a:p>
            <a:r>
              <a:rPr lang="en-US" sz="1800" b="1" dirty="0">
                <a:solidFill>
                  <a:srgbClr val="0070C0"/>
                </a:solidFill>
              </a:rPr>
              <a:t>Additional</a:t>
            </a:r>
            <a:r>
              <a:rPr lang="en-US" b="1" dirty="0">
                <a:solidFill>
                  <a:srgbClr val="0070C0"/>
                </a:solidFill>
              </a:rPr>
              <a:t> </a:t>
            </a:r>
            <a:r>
              <a:rPr lang="en-US" sz="1800" b="1" dirty="0">
                <a:solidFill>
                  <a:srgbClr val="0070C0"/>
                </a:solidFill>
              </a:rPr>
              <a:t>material</a:t>
            </a:r>
            <a:endParaRPr lang="en-US" b="1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638557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E138F8B-91D3-EEBD-128B-1F544237CF8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 Placeholder 2">
            <a:extLst>
              <a:ext uri="{FF2B5EF4-FFF2-40B4-BE49-F238E27FC236}">
                <a16:creationId xmlns:a16="http://schemas.microsoft.com/office/drawing/2014/main" id="{2A168DD4-83DB-BA10-8EA0-17CB1466ABB6}"/>
              </a:ext>
            </a:extLst>
          </p:cNvPr>
          <p:cNvSpPr txBox="1">
            <a:spLocks/>
          </p:cNvSpPr>
          <p:nvPr/>
        </p:nvSpPr>
        <p:spPr>
          <a:xfrm>
            <a:off x="1292221" y="1026191"/>
            <a:ext cx="321980" cy="524321"/>
          </a:xfrm>
          <a:prstGeom prst="rect">
            <a:avLst/>
          </a:prstGeom>
          <a:solidFill>
            <a:schemeClr val="bg1"/>
          </a:solidFill>
        </p:spPr>
        <p:txBody>
          <a:bodyPr vert="horz" lIns="74295" tIns="37148" rIns="74295" bIns="37148" rtlCol="0" anchor="b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950" dirty="0"/>
              <a:t>A</a:t>
            </a:r>
            <a:endParaRPr lang="en-US" sz="1950" dirty="0">
              <a:ea typeface="Calibri"/>
              <a:cs typeface="Calibri"/>
            </a:endParaRPr>
          </a:p>
        </p:txBody>
      </p:sp>
      <p:sp>
        <p:nvSpPr>
          <p:cNvPr id="8" name="Text Placeholder 2">
            <a:extLst>
              <a:ext uri="{FF2B5EF4-FFF2-40B4-BE49-F238E27FC236}">
                <a16:creationId xmlns:a16="http://schemas.microsoft.com/office/drawing/2014/main" id="{E42CEC91-AAE0-5944-88E2-FA9CC8D76E43}"/>
              </a:ext>
            </a:extLst>
          </p:cNvPr>
          <p:cNvSpPr txBox="1">
            <a:spLocks/>
          </p:cNvSpPr>
          <p:nvPr/>
        </p:nvSpPr>
        <p:spPr>
          <a:xfrm>
            <a:off x="1292221" y="2239043"/>
            <a:ext cx="321980" cy="524321"/>
          </a:xfrm>
          <a:prstGeom prst="rect">
            <a:avLst/>
          </a:prstGeom>
          <a:solidFill>
            <a:schemeClr val="bg1"/>
          </a:solidFill>
        </p:spPr>
        <p:txBody>
          <a:bodyPr vert="horz" lIns="74295" tIns="37148" rIns="74295" bIns="37148" rtlCol="0" anchor="b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950" dirty="0"/>
              <a:t>B</a:t>
            </a:r>
          </a:p>
        </p:txBody>
      </p:sp>
      <p:sp>
        <p:nvSpPr>
          <p:cNvPr id="9" name="Text Placeholder 2">
            <a:extLst>
              <a:ext uri="{FF2B5EF4-FFF2-40B4-BE49-F238E27FC236}">
                <a16:creationId xmlns:a16="http://schemas.microsoft.com/office/drawing/2014/main" id="{7C83527F-8490-9621-B68B-1877E18D3FE7}"/>
              </a:ext>
            </a:extLst>
          </p:cNvPr>
          <p:cNvSpPr txBox="1">
            <a:spLocks/>
          </p:cNvSpPr>
          <p:nvPr/>
        </p:nvSpPr>
        <p:spPr>
          <a:xfrm>
            <a:off x="1292222" y="3520427"/>
            <a:ext cx="321979" cy="524321"/>
          </a:xfrm>
          <a:prstGeom prst="rect">
            <a:avLst/>
          </a:prstGeom>
          <a:solidFill>
            <a:schemeClr val="bg1"/>
          </a:solidFill>
        </p:spPr>
        <p:txBody>
          <a:bodyPr vert="horz" lIns="74295" tIns="37148" rIns="74295" bIns="37148" rtlCol="0" anchor="b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950" dirty="0"/>
              <a:t>C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57D3DB09-0DB6-C0AD-865E-156B08D7F19F}"/>
              </a:ext>
            </a:extLst>
          </p:cNvPr>
          <p:cNvSpPr/>
          <p:nvPr/>
        </p:nvSpPr>
        <p:spPr>
          <a:xfrm>
            <a:off x="879267" y="180236"/>
            <a:ext cx="9375778" cy="276999"/>
          </a:xfrm>
          <a:prstGeom prst="rect">
            <a:avLst/>
          </a:prstGeom>
          <a:noFill/>
          <a:ln>
            <a:noFill/>
          </a:ln>
        </p:spPr>
        <p:txBody>
          <a:bodyPr wrap="square" lIns="91440" tIns="45720" rIns="91440" bIns="45720" anchor="t">
            <a:spAutoFit/>
          </a:bodyPr>
          <a:lstStyle/>
          <a:p>
            <a:pPr algn="ctr"/>
            <a:r>
              <a:rPr lang="en-US" sz="1200" b="1" dirty="0">
                <a:solidFill>
                  <a:srgbClr val="000000">
                    <a:alpha val="100000"/>
                  </a:srgbClr>
                </a:solidFill>
                <a:ea typeface="맑은 고딕"/>
              </a:rPr>
              <a:t>Figure S1</a:t>
            </a:r>
            <a:r>
              <a:rPr sz="1200" b="1" dirty="0">
                <a:solidFill>
                  <a:srgbClr val="000000">
                    <a:alpha val="100000"/>
                  </a:srgbClr>
                </a:solidFill>
                <a:ea typeface="맑은 고딕"/>
              </a:rPr>
              <a:t>.</a:t>
            </a:r>
            <a:r>
              <a:rPr sz="1200" dirty="0">
                <a:solidFill>
                  <a:srgbClr val="000000">
                    <a:alpha val="100000"/>
                  </a:srgbClr>
                </a:solidFill>
                <a:ea typeface="맑은 고딕"/>
              </a:rPr>
              <a:t> </a:t>
            </a:r>
            <a:r>
              <a:rPr lang="en-US" sz="1200" dirty="0">
                <a:solidFill>
                  <a:srgbClr val="000000">
                    <a:alpha val="100000"/>
                  </a:srgbClr>
                </a:solidFill>
                <a:ea typeface="맑은 고딕"/>
              </a:rPr>
              <a:t>ECG status before ischemia (A), during </a:t>
            </a:r>
            <a:r>
              <a:rPr lang="en-US" sz="1200" dirty="0">
                <a:solidFill>
                  <a:srgbClr val="000000">
                    <a:alpha val="100000"/>
                  </a:srgbClr>
                </a:solidFill>
                <a:ea typeface="Malgun Gothic"/>
              </a:rPr>
              <a:t>ischemia</a:t>
            </a:r>
            <a:r>
              <a:rPr lang="en-US" sz="1200" dirty="0">
                <a:solidFill>
                  <a:srgbClr val="000000">
                    <a:alpha val="100000"/>
                  </a:srgbClr>
                </a:solidFill>
                <a:ea typeface="맑은 고딕"/>
              </a:rPr>
              <a:t> (B) and 2 hours during reperfusion (C). </a:t>
            </a:r>
            <a:r>
              <a:rPr lang="en-US" sz="1200" dirty="0">
                <a:solidFill>
                  <a:srgbClr val="000000">
                    <a:alpha val="100000"/>
                  </a:srgbClr>
                </a:solidFill>
                <a:ea typeface="Malgun Gothic"/>
              </a:rPr>
              <a:t>ECG: electrocardiogram</a:t>
            </a:r>
            <a:r>
              <a:rPr lang="en-US" sz="1200" dirty="0">
                <a:solidFill>
                  <a:srgbClr val="000000">
                    <a:alpha val="100000"/>
                  </a:srgbClr>
                </a:solidFill>
                <a:ea typeface="맑은 고딕"/>
              </a:rPr>
              <a:t> </a:t>
            </a:r>
            <a:endParaRPr sz="1200" dirty="0">
              <a:solidFill>
                <a:srgbClr val="000000">
                  <a:alpha val="100000"/>
                </a:srgbClr>
              </a:solidFill>
              <a:ea typeface="맑은 고딕"/>
            </a:endParaRPr>
          </a:p>
        </p:txBody>
      </p:sp>
      <p:pic>
        <p:nvPicPr>
          <p:cNvPr id="3" name="Picture 2" descr="A graph showing a heart rate&#10;&#10;AI-generated content may be incorrect.">
            <a:extLst>
              <a:ext uri="{FF2B5EF4-FFF2-40B4-BE49-F238E27FC236}">
                <a16:creationId xmlns:a16="http://schemas.microsoft.com/office/drawing/2014/main" id="{AB0DF7C8-D7F2-904F-F238-DA8254FB917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35"/>
          <a:stretch/>
        </p:blipFill>
        <p:spPr>
          <a:xfrm>
            <a:off x="1614201" y="653493"/>
            <a:ext cx="7019728" cy="1193708"/>
          </a:xfrm>
          <a:prstGeom prst="rect">
            <a:avLst/>
          </a:prstGeom>
          <a:ln>
            <a:solidFill>
              <a:schemeClr val="bg1">
                <a:lumMod val="75000"/>
              </a:schemeClr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F9E09A17-A7AA-8894-1ECB-A58EFB92941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1535"/>
          <a:stretch/>
        </p:blipFill>
        <p:spPr>
          <a:xfrm>
            <a:off x="1614201" y="3189470"/>
            <a:ext cx="7019728" cy="1287946"/>
          </a:xfrm>
          <a:prstGeom prst="rect">
            <a:avLst/>
          </a:prstGeom>
          <a:ln w="9525">
            <a:solidFill>
              <a:schemeClr val="bg1">
                <a:lumMod val="75000"/>
              </a:schemeClr>
            </a:solidFill>
          </a:ln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D550D934-6144-EE13-6E0B-7D96D0799B9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14201" y="1884554"/>
            <a:ext cx="7019728" cy="1263100"/>
          </a:xfrm>
          <a:prstGeom prst="rect">
            <a:avLst/>
          </a:prstGeom>
          <a:ln w="9525">
            <a:solidFill>
              <a:schemeClr val="bg1">
                <a:lumMod val="7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25531357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02316F54-F5E5-D2B6-071E-9D44AEBA37D2}"/>
              </a:ext>
            </a:extLst>
          </p:cNvPr>
          <p:cNvSpPr/>
          <p:nvPr/>
        </p:nvSpPr>
        <p:spPr>
          <a:xfrm>
            <a:off x="998463" y="7412"/>
            <a:ext cx="10987059" cy="430887"/>
          </a:xfrm>
          <a:prstGeom prst="rect">
            <a:avLst/>
          </a:prstGeom>
          <a:noFill/>
          <a:ln>
            <a:noFill/>
          </a:ln>
        </p:spPr>
        <p:txBody>
          <a:bodyPr wrap="square" lIns="91440" tIns="45720" rIns="91440" bIns="45720" anchor="t">
            <a:spAutoFit/>
          </a:bodyPr>
          <a:lstStyle/>
          <a:p>
            <a:pPr algn="ctr"/>
            <a:r>
              <a:rPr lang="en-GB" sz="1100" b="1" dirty="0">
                <a:solidFill>
                  <a:srgbClr val="000000">
                    <a:alpha val="100000"/>
                  </a:srgbClr>
                </a:solidFill>
                <a:ea typeface="맑은 고딕"/>
              </a:rPr>
              <a:t>Video S1. </a:t>
            </a:r>
            <a:r>
              <a:rPr lang="en-US" sz="1100" dirty="0">
                <a:solidFill>
                  <a:srgbClr val="000000">
                    <a:alpha val="100000"/>
                  </a:srgbClr>
                </a:solidFill>
                <a:ea typeface="맑은 고딕"/>
              </a:rPr>
              <a:t>In vivo </a:t>
            </a:r>
            <a:r>
              <a:rPr lang="en-US" sz="1100" dirty="0">
                <a:solidFill>
                  <a:srgbClr val="000000">
                    <a:alpha val="100000"/>
                  </a:srgbClr>
                </a:solidFill>
                <a:ea typeface="Malgun Gothic"/>
              </a:rPr>
              <a:t>ischemia induction and reperfusion.</a:t>
            </a:r>
            <a:r>
              <a:rPr lang="en-US" sz="1100" dirty="0">
                <a:solidFill>
                  <a:srgbClr val="000000">
                    <a:alpha val="100000"/>
                  </a:srgbClr>
                </a:solidFill>
                <a:ea typeface="맑은 고딕"/>
              </a:rPr>
              <a:t> </a:t>
            </a:r>
            <a:r>
              <a:rPr lang="en-US" sz="1100" dirty="0">
                <a:solidFill>
                  <a:srgbClr val="000000">
                    <a:alpha val="100000"/>
                  </a:srgbClr>
                </a:solidFill>
                <a:ea typeface="Calibri"/>
                <a:cs typeface="Calibri"/>
              </a:rPr>
              <a:t>LAD artery was ligated with a snare for 30 minutes (ischemia) and the snare was released to restore blood flow (reperfusion).</a:t>
            </a:r>
          </a:p>
          <a:p>
            <a:pPr algn="ctr"/>
            <a:endParaRPr lang="en-US" sz="1100" dirty="0">
              <a:solidFill>
                <a:srgbClr val="000000">
                  <a:alpha val="100000"/>
                </a:srgbClr>
              </a:solidFill>
              <a:ea typeface="맑은 고딕"/>
            </a:endParaRPr>
          </a:p>
        </p:txBody>
      </p:sp>
      <p:pic>
        <p:nvPicPr>
          <p:cNvPr id="2" name="LAD ligation snare">
            <a:hlinkClick r:id="" action="ppaction://media"/>
            <a:extLst>
              <a:ext uri="{FF2B5EF4-FFF2-40B4-BE49-F238E27FC236}">
                <a16:creationId xmlns:a16="http://schemas.microsoft.com/office/drawing/2014/main" id="{A5979011-FD42-D72B-B96D-02FA9E51837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267965" y="356919"/>
            <a:ext cx="9656069" cy="600928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063BE99-3052-954A-AE01-525AB87A1A19}"/>
              </a:ext>
            </a:extLst>
          </p:cNvPr>
          <p:cNvSpPr txBox="1"/>
          <p:nvPr/>
        </p:nvSpPr>
        <p:spPr>
          <a:xfrm>
            <a:off x="1121859" y="6386398"/>
            <a:ext cx="725620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/>
              <a:t>Link</a:t>
            </a:r>
            <a:r>
              <a:rPr lang="en-GB" dirty="0"/>
              <a:t>: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F289105-68FC-F08E-BA85-5EDE8658982C}"/>
              </a:ext>
            </a:extLst>
          </p:cNvPr>
          <p:cNvSpPr txBox="1"/>
          <p:nvPr/>
        </p:nvSpPr>
        <p:spPr>
          <a:xfrm>
            <a:off x="1601174" y="6386398"/>
            <a:ext cx="6096000" cy="375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u="sng" dirty="0">
                <a:solidFill>
                  <a:srgbClr val="0000FF"/>
                </a:solidFill>
                <a:effectLst/>
                <a:latin typeface="Calibri" panose="020F0502020204030204" pitchFamily="34" charset="0"/>
                <a:ea typeface="Malgun Gothic" panose="020B0503020000020004" pitchFamily="34" charset="-127"/>
                <a:cs typeface="Calibri" panose="020F0502020204030204" pitchFamily="34" charset="0"/>
                <a:hlinkClick r:id="rId5"/>
              </a:rPr>
              <a:t>LAD temporary ligation snare.mp4</a:t>
            </a:r>
            <a:endParaRPr lang="en-US" sz="18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872280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166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E397194-1F59-6867-A258-0283B30C0F06}"/>
              </a:ext>
            </a:extLst>
          </p:cNvPr>
          <p:cNvSpPr/>
          <p:nvPr/>
        </p:nvSpPr>
        <p:spPr>
          <a:xfrm>
            <a:off x="-168152" y="0"/>
            <a:ext cx="6539456" cy="276999"/>
          </a:xfrm>
          <a:prstGeom prst="rect">
            <a:avLst/>
          </a:prstGeom>
          <a:noFill/>
          <a:ln>
            <a:noFill/>
          </a:ln>
        </p:spPr>
        <p:txBody>
          <a:bodyPr wrap="square" lIns="91440" tIns="45720" rIns="91440" bIns="45720" anchor="t">
            <a:spAutoFit/>
          </a:bodyPr>
          <a:lstStyle/>
          <a:p>
            <a:pPr algn="ctr"/>
            <a:r>
              <a:rPr lang="en-US" sz="1200" b="1" dirty="0">
                <a:solidFill>
                  <a:srgbClr val="000000">
                    <a:alpha val="100000"/>
                  </a:srgbClr>
                </a:solidFill>
                <a:ea typeface="맑은 고딕"/>
              </a:rPr>
              <a:t>Video S2</a:t>
            </a:r>
            <a:r>
              <a:rPr sz="1200" b="1" dirty="0">
                <a:solidFill>
                  <a:srgbClr val="000000">
                    <a:alpha val="100000"/>
                  </a:srgbClr>
                </a:solidFill>
                <a:ea typeface="맑은 고딕"/>
              </a:rPr>
              <a:t>.</a:t>
            </a:r>
            <a:r>
              <a:rPr sz="1200" dirty="0">
                <a:solidFill>
                  <a:srgbClr val="000000">
                    <a:alpha val="100000"/>
                  </a:srgbClr>
                </a:solidFill>
                <a:ea typeface="맑은 고딕"/>
              </a:rPr>
              <a:t> </a:t>
            </a:r>
            <a:r>
              <a:rPr lang="en-US" sz="1200" dirty="0">
                <a:solidFill>
                  <a:srgbClr val="000000">
                    <a:alpha val="100000"/>
                  </a:srgbClr>
                </a:solidFill>
                <a:ea typeface="맑은 고딕"/>
              </a:rPr>
              <a:t>Neonatal rat cardiomyocytes after 24 hours in culture. </a:t>
            </a:r>
            <a:endParaRPr sz="1200" dirty="0">
              <a:solidFill>
                <a:srgbClr val="000000">
                  <a:alpha val="100000"/>
                </a:srgbClr>
              </a:solidFill>
              <a:ea typeface="맑은 고딕"/>
            </a:endParaRPr>
          </a:p>
        </p:txBody>
      </p:sp>
      <p:pic>
        <p:nvPicPr>
          <p:cNvPr id="2" name="neonatal rat cardiomyocytes in culture">
            <a:hlinkClick r:id="" action="ppaction://media"/>
            <a:extLst>
              <a:ext uri="{FF2B5EF4-FFF2-40B4-BE49-F238E27FC236}">
                <a16:creationId xmlns:a16="http://schemas.microsoft.com/office/drawing/2014/main" id="{09177E02-046A-AF56-08B1-0B24EED38C35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rcRect l="9910" r="1317"/>
          <a:stretch/>
        </p:blipFill>
        <p:spPr>
          <a:xfrm>
            <a:off x="1050407" y="329848"/>
            <a:ext cx="8913947" cy="619830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F66A759-C64C-3E6A-1F1B-9E68B9AC4C7C}"/>
              </a:ext>
            </a:extLst>
          </p:cNvPr>
          <p:cNvSpPr txBox="1"/>
          <p:nvPr/>
        </p:nvSpPr>
        <p:spPr>
          <a:xfrm>
            <a:off x="1828799" y="6522296"/>
            <a:ext cx="6096000" cy="375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u="sng" dirty="0">
                <a:solidFill>
                  <a:srgbClr val="0000FF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  <a:hlinkClick r:id="rId6"/>
              </a:rPr>
              <a:t>neonatal rat cardiomyocytes in culture.mp4</a:t>
            </a:r>
            <a:endParaRPr lang="en-US" sz="24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69CD73D-FB2B-70D9-5EAC-A968B1AF7918}"/>
              </a:ext>
            </a:extLst>
          </p:cNvPr>
          <p:cNvSpPr txBox="1"/>
          <p:nvPr/>
        </p:nvSpPr>
        <p:spPr>
          <a:xfrm>
            <a:off x="1050407" y="6522296"/>
            <a:ext cx="62146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600" dirty="0"/>
              <a:t>Link</a:t>
            </a:r>
            <a:r>
              <a:rPr lang="en-GB" dirty="0"/>
              <a:t>: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7713671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033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F410525-B73F-ED75-A6DD-F1264AD8FB1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B0EC721-9204-38B9-0F82-274F2F1E761E}"/>
              </a:ext>
            </a:extLst>
          </p:cNvPr>
          <p:cNvSpPr txBox="1"/>
          <p:nvPr/>
        </p:nvSpPr>
        <p:spPr>
          <a:xfrm>
            <a:off x="2819706" y="1813804"/>
            <a:ext cx="766249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IN" sz="9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en-IN" sz="9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217CFA1-0AB3-5475-92D4-C9A39C7097FF}"/>
              </a:ext>
            </a:extLst>
          </p:cNvPr>
          <p:cNvSpPr txBox="1"/>
          <p:nvPr/>
        </p:nvSpPr>
        <p:spPr>
          <a:xfrm>
            <a:off x="1832824" y="1359834"/>
            <a:ext cx="115880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IN" sz="16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TRIAL -1</a:t>
            </a:r>
            <a:endParaRPr lang="en-IN" sz="16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1019166-BBA3-65E1-3DC0-A6C48F41DB98}"/>
              </a:ext>
            </a:extLst>
          </p:cNvPr>
          <p:cNvSpPr txBox="1"/>
          <p:nvPr/>
        </p:nvSpPr>
        <p:spPr>
          <a:xfrm>
            <a:off x="1005329" y="1736859"/>
            <a:ext cx="59592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IN" sz="9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HIF-1</a:t>
            </a:r>
            <a:r>
              <a:rPr lang="el-GR" sz="1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IN" sz="9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D64958C-6C90-4C4F-BEB0-113C49C3401A}"/>
              </a:ext>
            </a:extLst>
          </p:cNvPr>
          <p:cNvSpPr txBox="1"/>
          <p:nvPr/>
        </p:nvSpPr>
        <p:spPr>
          <a:xfrm>
            <a:off x="3639287" y="210065"/>
            <a:ext cx="443076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IN" sz="16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Protein expression of HIF-1</a:t>
            </a:r>
            <a:r>
              <a:rPr lang="el-GR" sz="16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IN" sz="16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 (Western Blot)</a:t>
            </a:r>
            <a:endParaRPr lang="en-IN" sz="16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D6A64FB-8CB8-1822-0119-B47ABA96EC8F}"/>
              </a:ext>
            </a:extLst>
          </p:cNvPr>
          <p:cNvSpPr txBox="1"/>
          <p:nvPr/>
        </p:nvSpPr>
        <p:spPr>
          <a:xfrm>
            <a:off x="5425630" y="1359834"/>
            <a:ext cx="115880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IN" sz="16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TRIAL -2</a:t>
            </a:r>
            <a:endParaRPr lang="en-IN" sz="16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276490F-0E2E-0615-8B0A-AE064E67B664}"/>
              </a:ext>
            </a:extLst>
          </p:cNvPr>
          <p:cNvSpPr txBox="1"/>
          <p:nvPr/>
        </p:nvSpPr>
        <p:spPr>
          <a:xfrm>
            <a:off x="6743490" y="1826058"/>
            <a:ext cx="766249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IN" sz="9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en-IN" sz="9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79D33E4-9603-AE5B-517A-68597EC90F45}"/>
              </a:ext>
            </a:extLst>
          </p:cNvPr>
          <p:cNvSpPr txBox="1"/>
          <p:nvPr/>
        </p:nvSpPr>
        <p:spPr>
          <a:xfrm>
            <a:off x="4919166" y="1736859"/>
            <a:ext cx="59592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IN" sz="9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HIF-1</a:t>
            </a:r>
            <a:r>
              <a:rPr lang="el-GR" sz="1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IN" sz="9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17" name="Picture 16" descr="A close-up of a person's legs&#10;&#10;Description automatically generated">
            <a:extLst>
              <a:ext uri="{FF2B5EF4-FFF2-40B4-BE49-F238E27FC236}">
                <a16:creationId xmlns:a16="http://schemas.microsoft.com/office/drawing/2014/main" id="{D3FA8F2B-FB65-1E83-115D-542BA8DED7F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655" t="1871" r="41927" b="39604"/>
          <a:stretch>
            <a:fillRect/>
          </a:stretch>
        </p:blipFill>
        <p:spPr>
          <a:xfrm flipH="1">
            <a:off x="4343241" y="2048347"/>
            <a:ext cx="1773319" cy="34149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D76FF61-DB3D-B9BD-3E35-41A96A2321E3}"/>
              </a:ext>
            </a:extLst>
          </p:cNvPr>
          <p:cNvSpPr txBox="1"/>
          <p:nvPr/>
        </p:nvSpPr>
        <p:spPr>
          <a:xfrm>
            <a:off x="9769384" y="1415439"/>
            <a:ext cx="115880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IN" sz="16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TRIAL -3</a:t>
            </a:r>
            <a:endParaRPr lang="en-IN" sz="16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206B845-F0BC-3332-30CA-87E1F2B3CEA2}"/>
              </a:ext>
            </a:extLst>
          </p:cNvPr>
          <p:cNvSpPr txBox="1"/>
          <p:nvPr/>
        </p:nvSpPr>
        <p:spPr>
          <a:xfrm>
            <a:off x="10657720" y="1807853"/>
            <a:ext cx="766249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IN" sz="9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en-IN" sz="9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859593F-2FC7-5BB9-3512-4889DB849F33}"/>
              </a:ext>
            </a:extLst>
          </p:cNvPr>
          <p:cNvSpPr txBox="1"/>
          <p:nvPr/>
        </p:nvSpPr>
        <p:spPr>
          <a:xfrm>
            <a:off x="8977332" y="1769381"/>
            <a:ext cx="59592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IN" sz="9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HIF-1</a:t>
            </a:r>
            <a:r>
              <a:rPr lang="el-GR" sz="1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IN" sz="9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24" name="Picture 23" descr="A black and white image of a rectangular object&#10;&#10;Description automatically generated">
            <a:extLst>
              <a:ext uri="{FF2B5EF4-FFF2-40B4-BE49-F238E27FC236}">
                <a16:creationId xmlns:a16="http://schemas.microsoft.com/office/drawing/2014/main" id="{0A3458B7-2580-5F7E-B5F8-BDBAE042DFD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66" t="16343" r="52193" b="24530"/>
          <a:stretch>
            <a:fillRect/>
          </a:stretch>
        </p:blipFill>
        <p:spPr>
          <a:xfrm>
            <a:off x="10348785" y="2077158"/>
            <a:ext cx="1544594" cy="32885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 descr="A white rectangular object with black spots&#10;&#10;Description automatically generated">
            <a:extLst>
              <a:ext uri="{FF2B5EF4-FFF2-40B4-BE49-F238E27FC236}">
                <a16:creationId xmlns:a16="http://schemas.microsoft.com/office/drawing/2014/main" id="{1B5FE6B3-3EF1-6A25-C1A6-00B7C68C619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78" t="22257" r="41086" b="17099"/>
          <a:stretch>
            <a:fillRect/>
          </a:stretch>
        </p:blipFill>
        <p:spPr>
          <a:xfrm>
            <a:off x="8373646" y="2077158"/>
            <a:ext cx="1882461" cy="33211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 descr="A close-up of a rectangular object&#10;&#10;Description automatically generated">
            <a:extLst>
              <a:ext uri="{FF2B5EF4-FFF2-40B4-BE49-F238E27FC236}">
                <a16:creationId xmlns:a16="http://schemas.microsoft.com/office/drawing/2014/main" id="{E13F5706-D119-F27E-B8C8-CBA7B5B7913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39" t="30480" r="41475" b="17692"/>
          <a:stretch>
            <a:fillRect/>
          </a:stretch>
        </p:blipFill>
        <p:spPr>
          <a:xfrm>
            <a:off x="6315173" y="2077158"/>
            <a:ext cx="1622884" cy="33861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Picture 21" descr="A close-up of a paper&#10;&#10;Description automatically generated">
            <a:extLst>
              <a:ext uri="{FF2B5EF4-FFF2-40B4-BE49-F238E27FC236}">
                <a16:creationId xmlns:a16="http://schemas.microsoft.com/office/drawing/2014/main" id="{A8A73E71-7963-D499-AB3C-5422AA68688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02" t="28964" r="38298" b="26568"/>
          <a:stretch/>
        </p:blipFill>
        <p:spPr>
          <a:xfrm>
            <a:off x="549808" y="2038685"/>
            <a:ext cx="1640856" cy="34038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Picture 24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F58EDD80-26FC-7BFD-255D-356E3A8B0DF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00" t="20742" r="41343" b="23150"/>
          <a:stretch/>
        </p:blipFill>
        <p:spPr>
          <a:xfrm>
            <a:off x="2399875" y="2038686"/>
            <a:ext cx="1644858" cy="34246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AFC2D9AD-9777-D4A6-798E-357A97570306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22935" t="76591" r="13019"/>
          <a:stretch/>
        </p:blipFill>
        <p:spPr>
          <a:xfrm>
            <a:off x="516342" y="5453891"/>
            <a:ext cx="1453642" cy="915686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B21F27C3-604B-7D25-31F7-794716C09B59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22935" t="76591" r="13019"/>
          <a:stretch/>
        </p:blipFill>
        <p:spPr>
          <a:xfrm>
            <a:off x="2197403" y="5498164"/>
            <a:ext cx="1453642" cy="915686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A24FE42E-8106-DA34-B50E-B4B995017651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22935" t="76591" r="13019"/>
          <a:stretch/>
        </p:blipFill>
        <p:spPr>
          <a:xfrm>
            <a:off x="4192345" y="5498164"/>
            <a:ext cx="1453642" cy="915686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2362448F-0282-906B-5AC3-41874BE7AE08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22935" t="76591" r="13019"/>
          <a:stretch/>
        </p:blipFill>
        <p:spPr>
          <a:xfrm>
            <a:off x="6064727" y="5498164"/>
            <a:ext cx="1453642" cy="915686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21F5A4F9-F597-71A3-BF87-291B0F30C536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22935" t="76591" r="13019"/>
          <a:stretch/>
        </p:blipFill>
        <p:spPr>
          <a:xfrm>
            <a:off x="8648845" y="5430794"/>
            <a:ext cx="1453642" cy="915686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8CA6D150-CB4D-716D-38A4-CEF6691541A7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22935" t="76591" r="13019"/>
          <a:stretch/>
        </p:blipFill>
        <p:spPr>
          <a:xfrm>
            <a:off x="10267987" y="5398272"/>
            <a:ext cx="1453642" cy="9156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53348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50EA6C1-28CC-99C4-AD9E-1ABD2608B878}"/>
              </a:ext>
            </a:extLst>
          </p:cNvPr>
          <p:cNvSpPr txBox="1"/>
          <p:nvPr/>
        </p:nvSpPr>
        <p:spPr>
          <a:xfrm>
            <a:off x="3048000" y="3246792"/>
            <a:ext cx="6096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2400" b="1" dirty="0"/>
              <a:t>End.</a:t>
            </a:r>
            <a:endParaRPr 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34102892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53</TotalTime>
  <Words>154</Words>
  <Application>Microsoft Office PowerPoint</Application>
  <PresentationFormat>Widescreen</PresentationFormat>
  <Paragraphs>26</Paragraphs>
  <Slides>6</Slides>
  <Notes>3</Notes>
  <HiddenSlides>0</HiddenSlides>
  <MMClips>2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맑은 고딕</vt:lpstr>
      <vt:lpstr>맑은 고딕</vt:lpstr>
      <vt:lpstr>Aptos</vt:lpstr>
      <vt:lpstr>Aptos Display</vt:lpstr>
      <vt:lpstr>Arial</vt:lpstr>
      <vt:lpstr>Calibri</vt:lpstr>
      <vt:lpstr>Times New Roman</vt:lpstr>
      <vt:lpstr>Office Theme</vt:lpstr>
      <vt:lpstr>Pretreatment Mitigates Myocardial Ischemia-Reperfusion Injury through Preservation of Mitochondrial Respiration: A Combined Assessment of  In vivo, Ex vivo, and In vitro Data 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treatment Mitigates Myocardial Ischemia-Reperfusion Injury through Preservation of Mitochondrial Respiration: A Combined Assessment of  In vivo, Ex vivo, and In vitro Data </dc:title>
  <dc:creator>HABIMANA REVERIEN</dc:creator>
  <cp:lastModifiedBy>HABIMANA REVERIEN</cp:lastModifiedBy>
  <cp:revision>19</cp:revision>
  <dcterms:created xsi:type="dcterms:W3CDTF">2025-07-25T05:10:11Z</dcterms:created>
  <dcterms:modified xsi:type="dcterms:W3CDTF">2025-11-18T12:50:42Z</dcterms:modified>
</cp:coreProperties>
</file>